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63" d="100"/>
          <a:sy n="63" d="100"/>
        </p:scale>
        <p:origin x="728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2228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287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6108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7449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8008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303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1945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254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29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2884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1374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53F99E-2F72-41B1-B414-43E4057B5E5E}" type="datetimeFigureOut">
              <a:rPr lang="de-DE" smtClean="0"/>
              <a:t>14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F219B-0DDD-4D4E-AF84-156F237E361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6792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microsoft.com/office/2007/relationships/hdphoto" Target="../media/hdphoto1.wdp"/><Relationship Id="rId10" Type="http://schemas.openxmlformats.org/officeDocument/2006/relationships/image" Target="../media/image8.jpeg"/><Relationship Id="rId4" Type="http://schemas.openxmlformats.org/officeDocument/2006/relationships/image" Target="../media/image3.png"/><Relationship Id="rId9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277455" y="4278356"/>
            <a:ext cx="2835000" cy="20160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277455" y="1394910"/>
            <a:ext cx="2835000" cy="201600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374397" y="1394910"/>
            <a:ext cx="2835000" cy="201600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374397" y="4278356"/>
            <a:ext cx="2835000" cy="201600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3255480" y="367957"/>
            <a:ext cx="9375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KT/TAZ</a:t>
            </a:r>
          </a:p>
        </p:txBody>
      </p:sp>
      <p:cxnSp>
        <p:nvCxnSpPr>
          <p:cNvPr id="8" name="Gerader Verbinder 7"/>
          <p:cNvCxnSpPr/>
          <p:nvPr/>
        </p:nvCxnSpPr>
        <p:spPr>
          <a:xfrm>
            <a:off x="1696390" y="678415"/>
            <a:ext cx="41035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/>
          <p:cNvSpPr txBox="1"/>
          <p:nvPr/>
        </p:nvSpPr>
        <p:spPr>
          <a:xfrm>
            <a:off x="2321913" y="695159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4409420" y="695159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2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7602618" y="374347"/>
            <a:ext cx="16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KT/TAZ/HSF1dn</a:t>
            </a:r>
          </a:p>
        </p:txBody>
      </p:sp>
      <p:cxnSp>
        <p:nvCxnSpPr>
          <p:cNvPr id="12" name="Gerader Verbinder 11"/>
          <p:cNvCxnSpPr/>
          <p:nvPr/>
        </p:nvCxnSpPr>
        <p:spPr>
          <a:xfrm>
            <a:off x="6350912" y="679350"/>
            <a:ext cx="41035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6976435" y="696094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9063942" y="696094"/>
            <a:ext cx="764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#2</a:t>
            </a:r>
          </a:p>
        </p:txBody>
      </p:sp>
      <p:sp>
        <p:nvSpPr>
          <p:cNvPr id="21" name="Textfeld 20"/>
          <p:cNvSpPr txBox="1"/>
          <p:nvPr/>
        </p:nvSpPr>
        <p:spPr>
          <a:xfrm rot="16200000">
            <a:off x="1262528" y="2278475"/>
            <a:ext cx="5084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</a:p>
        </p:txBody>
      </p:sp>
      <p:sp>
        <p:nvSpPr>
          <p:cNvPr id="22" name="Textfeld 21"/>
          <p:cNvSpPr txBox="1"/>
          <p:nvPr/>
        </p:nvSpPr>
        <p:spPr>
          <a:xfrm rot="16200000">
            <a:off x="1228866" y="5197974"/>
            <a:ext cx="5758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K19</a:t>
            </a:r>
          </a:p>
        </p:txBody>
      </p:sp>
      <p:pic>
        <p:nvPicPr>
          <p:cNvPr id="25" name="Grafik 2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8028919" y="4278356"/>
            <a:ext cx="2835000" cy="2016000"/>
          </a:xfrm>
          <a:prstGeom prst="rect">
            <a:avLst/>
          </a:prstGeom>
        </p:spPr>
      </p:pic>
      <p:pic>
        <p:nvPicPr>
          <p:cNvPr id="26" name="Grafik 2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8024979" y="1394910"/>
            <a:ext cx="2835000" cy="2016000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928037" y="1394910"/>
            <a:ext cx="2835000" cy="2016000"/>
          </a:xfrm>
          <a:prstGeom prst="rect">
            <a:avLst/>
          </a:prstGeom>
        </p:spPr>
      </p:pic>
      <p:pic>
        <p:nvPicPr>
          <p:cNvPr id="28" name="Grafik 2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928037" y="4278356"/>
            <a:ext cx="2835000" cy="2016000"/>
          </a:xfrm>
          <a:prstGeom prst="rect">
            <a:avLst/>
          </a:prstGeom>
        </p:spPr>
      </p:pic>
      <p:sp>
        <p:nvSpPr>
          <p:cNvPr id="2" name="Textfeld 6">
            <a:extLst>
              <a:ext uri="{FF2B5EF4-FFF2-40B4-BE49-F238E27FC236}">
                <a16:creationId xmlns:a16="http://schemas.microsoft.com/office/drawing/2014/main" id="{82DE45CF-6230-297B-F4F6-089AD71B8541}"/>
              </a:ext>
            </a:extLst>
          </p:cNvPr>
          <p:cNvSpPr txBox="1"/>
          <p:nvPr/>
        </p:nvSpPr>
        <p:spPr>
          <a:xfrm>
            <a:off x="1308741" y="9182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feld 6">
            <a:extLst>
              <a:ext uri="{FF2B5EF4-FFF2-40B4-BE49-F238E27FC236}">
                <a16:creationId xmlns:a16="http://schemas.microsoft.com/office/drawing/2014/main" id="{654CAD4C-32E6-D5C5-95BC-41E1F2BBF74B}"/>
              </a:ext>
            </a:extLst>
          </p:cNvPr>
          <p:cNvSpPr txBox="1"/>
          <p:nvPr/>
        </p:nvSpPr>
        <p:spPr>
          <a:xfrm>
            <a:off x="5981182" y="9182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feld 20">
            <a:extLst>
              <a:ext uri="{FF2B5EF4-FFF2-40B4-BE49-F238E27FC236}">
                <a16:creationId xmlns:a16="http://schemas.microsoft.com/office/drawing/2014/main" id="{D6AD1171-8148-511E-E7CB-B9506CAE10D5}"/>
              </a:ext>
            </a:extLst>
          </p:cNvPr>
          <p:cNvSpPr txBox="1"/>
          <p:nvPr/>
        </p:nvSpPr>
        <p:spPr>
          <a:xfrm>
            <a:off x="6920392" y="5901651"/>
            <a:ext cx="2952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7" name="Textfeld 20">
            <a:extLst>
              <a:ext uri="{FF2B5EF4-FFF2-40B4-BE49-F238E27FC236}">
                <a16:creationId xmlns:a16="http://schemas.microsoft.com/office/drawing/2014/main" id="{AEA071E1-C3F3-2D3F-4687-1EB8F21E7313}"/>
              </a:ext>
            </a:extLst>
          </p:cNvPr>
          <p:cNvSpPr txBox="1"/>
          <p:nvPr/>
        </p:nvSpPr>
        <p:spPr>
          <a:xfrm>
            <a:off x="6419732" y="3985196"/>
            <a:ext cx="2952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BD3B5E44-7519-3AF7-4000-10DD1B9C1D2A}"/>
              </a:ext>
            </a:extLst>
          </p:cNvPr>
          <p:cNvCxnSpPr/>
          <p:nvPr/>
        </p:nvCxnSpPr>
        <p:spPr>
          <a:xfrm flipH="1">
            <a:off x="8915400" y="6178650"/>
            <a:ext cx="82296" cy="194718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E7BBEBD3-B0D5-2323-5F86-20B178682797}"/>
              </a:ext>
            </a:extLst>
          </p:cNvPr>
          <p:cNvCxnSpPr/>
          <p:nvPr/>
        </p:nvCxnSpPr>
        <p:spPr>
          <a:xfrm flipH="1">
            <a:off x="8779010" y="3390106"/>
            <a:ext cx="82296" cy="194718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26447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3C5BF8A-1B7A-3BD6-19D8-AE6B4083E1B0}"/>
              </a:ext>
            </a:extLst>
          </p:cNvPr>
          <p:cNvSpPr txBox="1"/>
          <p:nvPr/>
        </p:nvSpPr>
        <p:spPr>
          <a:xfrm>
            <a:off x="207264" y="223550"/>
            <a:ext cx="11777472" cy="4196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</a:pP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Inactivation of HSF1 via HSF1dn injection modifies the histopathological features of 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KT/</a:t>
            </a:r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Z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ouse lesions.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Two distinct AKT/TAZ mouse livers at 8 weeks post hydrodynamic injection are shown. The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olangiocellular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esions are characterized by a solid appearance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are CK19-positive. C</a:t>
            </a:r>
            <a:r>
              <a:rPr lang="en-GB" i="0" dirty="0" err="1">
                <a:solidFill>
                  <a:srgbClr val="0E101A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lusters</a:t>
            </a:r>
            <a:r>
              <a:rPr lang="en-GB" i="0" dirty="0">
                <a:solidFill>
                  <a:srgbClr val="0E101A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of lipid-rich, hepatocellular preneoplastic lesions can be observed in liver #1.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Two AKT/TAZ/HSF1dn mouse livers at 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6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eeks post hydrodynamic injection. In liver #1, the parenchyma is occupied by several and small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olangiocellular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esions that are CK-19 positive. However, the hepatocellular tumors (H), which are CK19-negative occupy most of the liver parenchyma. In liver #2, almost the whole parenchyma is occupied by hepatocellular, CK-19 negative, lesions. A 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mall CK19-positive </a:t>
            </a:r>
            <a:r>
              <a:rPr lang="en-US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olangiocellular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umor (indicated by an arrow),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some clusters of CK-19-positive cells can be also appreciated. Original magnification: 20x; scale bar: 1000 </a:t>
            </a:r>
            <a:r>
              <a:rPr lang="de-DE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. Abbreviation: H&amp;E, hematoxylin and eosin staining.</a:t>
            </a:r>
            <a:endParaRPr lang="en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1521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7</Words>
  <Application>Microsoft Office PowerPoint</Application>
  <PresentationFormat>Widescreen</PresentationFormat>
  <Paragraphs>1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 Presentation</vt:lpstr>
      <vt:lpstr>PowerPoint Presentation</vt:lpstr>
    </vt:vector>
  </TitlesOfParts>
  <Company>Universität Regens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ocalAdmin</dc:creator>
  <cp:lastModifiedBy>Diego Calvisi</cp:lastModifiedBy>
  <cp:revision>28</cp:revision>
  <dcterms:created xsi:type="dcterms:W3CDTF">2024-07-10T12:09:23Z</dcterms:created>
  <dcterms:modified xsi:type="dcterms:W3CDTF">2024-08-14T15:15:11Z</dcterms:modified>
</cp:coreProperties>
</file>